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F95AB1-18C9-42EC-963A-CC0FAAD702F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58E458-A097-4C0E-9A9F-A6F93BD96BD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50426C-D2C9-4D29-8DCF-D742766B74E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2E87C3-788D-4E58-A958-3D20584AB5E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C865F0-C8B6-48D6-8475-5851D891583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CD697C-64AE-4438-8CE3-5632B0E2CDF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10612A-9DFB-4A98-B108-E40ED6F8CE0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5B8344-EC06-43F6-B041-2044AB22D60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70F5D0-DECB-4445-8F3B-921A8005BDD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0B1AF2-47B9-4DC3-B395-08491F3FADE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8655E5-971D-4D3A-A6CD-2E2468D75DD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55B568-62A3-4BAE-8B25-CD506FC12B7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55A62D6-08E3-4C1A-934B-FF0D024388B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-34200" y="9360"/>
            <a:ext cx="17686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PT" sz="1200" spc="-1" strike="noStrike">
                <a:solidFill>
                  <a:srgbClr val="000000"/>
                </a:solidFill>
                <a:latin typeface="Arial"/>
              </a:rPr>
              <a:t>Supplementary data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PT" sz="1200" spc="-1" strike="noStrike">
                <a:solidFill>
                  <a:srgbClr val="000000"/>
                </a:solidFill>
                <a:latin typeface="Arial"/>
              </a:rPr>
              <a:t>Parreira et a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152280" y="1371600"/>
            <a:ext cx="6504480" cy="7820280"/>
            <a:chOff x="152280" y="1371600"/>
            <a:chExt cx="6504480" cy="7820280"/>
          </a:xfrm>
        </p:grpSpPr>
        <p:sp>
          <p:nvSpPr>
            <p:cNvPr id="43" name=""/>
            <p:cNvSpPr/>
            <p:nvPr/>
          </p:nvSpPr>
          <p:spPr>
            <a:xfrm>
              <a:off x="2459160" y="9038160"/>
              <a:ext cx="918000" cy="144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2868120" y="9084960"/>
              <a:ext cx="1119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0.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970200" y="6457320"/>
              <a:ext cx="596160" cy="860760"/>
            </a:xfrm>
            <a:custGeom>
              <a:avLst/>
              <a:gdLst/>
              <a:ahLst/>
              <a:rect l="l" t="t" r="r" b="b"/>
              <a:pathLst>
                <a:path w="2884" h="2398">
                  <a:moveTo>
                    <a:pt x="2884" y="0"/>
                  </a:moveTo>
                  <a:lnTo>
                    <a:pt x="0" y="0"/>
                  </a:lnTo>
                  <a:lnTo>
                    <a:pt x="0" y="2398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2739600" y="2233440"/>
              <a:ext cx="401040" cy="214560"/>
            </a:xfrm>
            <a:custGeom>
              <a:avLst/>
              <a:gdLst/>
              <a:ahLst/>
              <a:rect l="l" t="t" r="r" b="b"/>
              <a:pathLst>
                <a:path w="1942" h="597">
                  <a:moveTo>
                    <a:pt x="1942" y="0"/>
                  </a:moveTo>
                  <a:lnTo>
                    <a:pt x="0" y="0"/>
                  </a:lnTo>
                  <a:lnTo>
                    <a:pt x="0" y="597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3083760" y="2448360"/>
              <a:ext cx="226080" cy="54000"/>
            </a:xfrm>
            <a:custGeom>
              <a:avLst/>
              <a:gdLst/>
              <a:ahLst/>
              <a:rect l="l" t="t" r="r" b="b"/>
              <a:pathLst>
                <a:path w="1093" h="149">
                  <a:moveTo>
                    <a:pt x="1093" y="149"/>
                  </a:moveTo>
                  <a:lnTo>
                    <a:pt x="0" y="149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2449080" y="1858680"/>
              <a:ext cx="1027080" cy="121320"/>
            </a:xfrm>
            <a:custGeom>
              <a:avLst/>
              <a:gdLst/>
              <a:ahLst/>
              <a:rect l="l" t="t" r="r" b="b"/>
              <a:pathLst>
                <a:path w="4976" h="338">
                  <a:moveTo>
                    <a:pt x="4976" y="0"/>
                  </a:moveTo>
                  <a:lnTo>
                    <a:pt x="0" y="0"/>
                  </a:lnTo>
                  <a:lnTo>
                    <a:pt x="0" y="338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4960440" y="8079840"/>
              <a:ext cx="25920" cy="1440"/>
            </a:xfrm>
            <a:custGeom>
              <a:avLst/>
              <a:gdLst/>
              <a:ahLst/>
              <a:rect l="l" t="t" r="r" b="b"/>
              <a:pathLst>
                <a:path w="123" h="0">
                  <a:moveTo>
                    <a:pt x="123" y="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3712680" y="6041520"/>
              <a:ext cx="84600" cy="52560"/>
            </a:xfrm>
            <a:custGeom>
              <a:avLst/>
              <a:gdLst/>
              <a:ahLst/>
              <a:rect l="l" t="t" r="r" b="b"/>
              <a:pathLst>
                <a:path w="413" h="149">
                  <a:moveTo>
                    <a:pt x="413" y="0"/>
                  </a:moveTo>
                  <a:lnTo>
                    <a:pt x="0" y="0"/>
                  </a:lnTo>
                  <a:lnTo>
                    <a:pt x="0" y="149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60" bIns="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1566360" y="6457320"/>
              <a:ext cx="1270440" cy="92520"/>
            </a:xfrm>
            <a:custGeom>
              <a:avLst/>
              <a:gdLst/>
              <a:ahLst/>
              <a:rect l="l" t="t" r="r" b="b"/>
              <a:pathLst>
                <a:path w="6154" h="261">
                  <a:moveTo>
                    <a:pt x="6154" y="261"/>
                  </a:moveTo>
                  <a:lnTo>
                    <a:pt x="0" y="261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3434760" y="4915440"/>
              <a:ext cx="1063080" cy="160200"/>
            </a:xfrm>
            <a:custGeom>
              <a:avLst/>
              <a:gdLst/>
              <a:ahLst/>
              <a:rect l="l" t="t" r="r" b="b"/>
              <a:pathLst>
                <a:path w="5147" h="448">
                  <a:moveTo>
                    <a:pt x="5147" y="448"/>
                  </a:moveTo>
                  <a:lnTo>
                    <a:pt x="0" y="448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5205600" y="6845760"/>
              <a:ext cx="25920" cy="54000"/>
            </a:xfrm>
            <a:custGeom>
              <a:avLst/>
              <a:gdLst/>
              <a:ahLst/>
              <a:rect l="l" t="t" r="r" b="b"/>
              <a:pathLst>
                <a:path w="126" h="150">
                  <a:moveTo>
                    <a:pt x="126" y="150"/>
                  </a:moveTo>
                  <a:lnTo>
                    <a:pt x="0" y="150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1179360" y="2867760"/>
              <a:ext cx="1213560" cy="383760"/>
            </a:xfrm>
            <a:custGeom>
              <a:avLst/>
              <a:gdLst/>
              <a:ahLst/>
              <a:rect l="l" t="t" r="r" b="b"/>
              <a:pathLst>
                <a:path w="5879" h="1072">
                  <a:moveTo>
                    <a:pt x="5879" y="1072"/>
                  </a:moveTo>
                  <a:lnTo>
                    <a:pt x="0" y="1072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2900160" y="2823120"/>
              <a:ext cx="822240" cy="54000"/>
            </a:xfrm>
            <a:custGeom>
              <a:avLst/>
              <a:gdLst/>
              <a:ahLst/>
              <a:rect l="l" t="t" r="r" b="b"/>
              <a:pathLst>
                <a:path w="3982" h="149">
                  <a:moveTo>
                    <a:pt x="3982" y="0"/>
                  </a:moveTo>
                  <a:lnTo>
                    <a:pt x="0" y="0"/>
                  </a:lnTo>
                  <a:lnTo>
                    <a:pt x="0" y="149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3484800" y="4217760"/>
              <a:ext cx="1584360" cy="54000"/>
            </a:xfrm>
            <a:custGeom>
              <a:avLst/>
              <a:gdLst/>
              <a:ahLst/>
              <a:rect l="l" t="t" r="r" b="b"/>
              <a:pathLst>
                <a:path w="7667" h="150">
                  <a:moveTo>
                    <a:pt x="7667" y="0"/>
                  </a:moveTo>
                  <a:lnTo>
                    <a:pt x="0" y="0"/>
                  </a:lnTo>
                  <a:lnTo>
                    <a:pt x="0" y="15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4960440" y="7757280"/>
              <a:ext cx="90000" cy="322200"/>
            </a:xfrm>
            <a:custGeom>
              <a:avLst/>
              <a:gdLst/>
              <a:ahLst/>
              <a:rect l="l" t="t" r="r" b="b"/>
              <a:pathLst>
                <a:path w="437" h="896">
                  <a:moveTo>
                    <a:pt x="437" y="0"/>
                  </a:moveTo>
                  <a:lnTo>
                    <a:pt x="0" y="0"/>
                  </a:lnTo>
                  <a:lnTo>
                    <a:pt x="0" y="896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4960440" y="8079840"/>
              <a:ext cx="50040" cy="214560"/>
            </a:xfrm>
            <a:custGeom>
              <a:avLst/>
              <a:gdLst/>
              <a:ahLst/>
              <a:rect l="l" t="t" r="r" b="b"/>
              <a:pathLst>
                <a:path w="243" h="597">
                  <a:moveTo>
                    <a:pt x="243" y="597"/>
                  </a:moveTo>
                  <a:lnTo>
                    <a:pt x="0" y="597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3141000" y="2233440"/>
              <a:ext cx="151560" cy="54000"/>
            </a:xfrm>
            <a:custGeom>
              <a:avLst/>
              <a:gdLst/>
              <a:ahLst/>
              <a:rect l="l" t="t" r="r" b="b"/>
              <a:pathLst>
                <a:path w="730" h="149">
                  <a:moveTo>
                    <a:pt x="730" y="149"/>
                  </a:moveTo>
                  <a:lnTo>
                    <a:pt x="0" y="149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3434760" y="4915440"/>
              <a:ext cx="506880" cy="1080"/>
            </a:xfrm>
            <a:custGeom>
              <a:avLst/>
              <a:gdLst/>
              <a:ahLst/>
              <a:rect l="l" t="t" r="r" b="b"/>
              <a:pathLst>
                <a:path w="2456" h="0">
                  <a:moveTo>
                    <a:pt x="2456" y="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4113720" y="8508600"/>
              <a:ext cx="86040" cy="52560"/>
            </a:xfrm>
            <a:custGeom>
              <a:avLst/>
              <a:gdLst/>
              <a:ahLst/>
              <a:rect l="l" t="t" r="r" b="b"/>
              <a:pathLst>
                <a:path w="417" h="149">
                  <a:moveTo>
                    <a:pt x="417" y="0"/>
                  </a:moveTo>
                  <a:lnTo>
                    <a:pt x="0" y="0"/>
                  </a:lnTo>
                  <a:lnTo>
                    <a:pt x="0" y="149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60" bIns="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2381760" y="3682440"/>
              <a:ext cx="1541520" cy="52200"/>
            </a:xfrm>
            <a:custGeom>
              <a:avLst/>
              <a:gdLst/>
              <a:ahLst/>
              <a:rect l="l" t="t" r="r" b="b"/>
              <a:pathLst>
                <a:path w="7465" h="149">
                  <a:moveTo>
                    <a:pt x="7465" y="0"/>
                  </a:moveTo>
                  <a:lnTo>
                    <a:pt x="0" y="0"/>
                  </a:lnTo>
                  <a:lnTo>
                    <a:pt x="0" y="149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152280" y="4705200"/>
              <a:ext cx="55800" cy="1440"/>
            </a:xfrm>
            <a:prstGeom prst="line">
              <a:avLst/>
            </a:prstGeom>
            <a:ln cap="rnd"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2648160" y="8180640"/>
              <a:ext cx="823680" cy="529200"/>
            </a:xfrm>
            <a:custGeom>
              <a:avLst/>
              <a:gdLst/>
              <a:ahLst/>
              <a:rect l="l" t="t" r="r" b="b"/>
              <a:pathLst>
                <a:path w="3990" h="1474">
                  <a:moveTo>
                    <a:pt x="3990" y="1474"/>
                  </a:moveTo>
                  <a:lnTo>
                    <a:pt x="0" y="1474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5046840" y="7120080"/>
              <a:ext cx="98640" cy="100440"/>
            </a:xfrm>
            <a:custGeom>
              <a:avLst/>
              <a:gdLst/>
              <a:ahLst/>
              <a:rect l="l" t="t" r="r" b="b"/>
              <a:pathLst>
                <a:path w="480" h="280">
                  <a:moveTo>
                    <a:pt x="480" y="280"/>
                  </a:moveTo>
                  <a:lnTo>
                    <a:pt x="0" y="280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4113720" y="8561520"/>
              <a:ext cx="64440" cy="54000"/>
            </a:xfrm>
            <a:custGeom>
              <a:avLst/>
              <a:gdLst/>
              <a:ahLst/>
              <a:rect l="l" t="t" r="r" b="b"/>
              <a:pathLst>
                <a:path w="310" h="150">
                  <a:moveTo>
                    <a:pt x="310" y="150"/>
                  </a:moveTo>
                  <a:lnTo>
                    <a:pt x="0" y="150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2739600" y="2448360"/>
              <a:ext cx="343800" cy="1080"/>
            </a:xfrm>
            <a:custGeom>
              <a:avLst/>
              <a:gdLst/>
              <a:ahLst/>
              <a:rect l="l" t="t" r="r" b="b"/>
              <a:pathLst>
                <a:path w="1665" h="0">
                  <a:moveTo>
                    <a:pt x="1665" y="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4304520" y="7329960"/>
              <a:ext cx="366480" cy="106560"/>
            </a:xfrm>
            <a:custGeom>
              <a:avLst/>
              <a:gdLst/>
              <a:ahLst/>
              <a:rect l="l" t="t" r="r" b="b"/>
              <a:pathLst>
                <a:path w="1773" h="296">
                  <a:moveTo>
                    <a:pt x="1773" y="0"/>
                  </a:moveTo>
                  <a:lnTo>
                    <a:pt x="0" y="0"/>
                  </a:lnTo>
                  <a:lnTo>
                    <a:pt x="0" y="296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2837160" y="6550200"/>
              <a:ext cx="587160" cy="80640"/>
            </a:xfrm>
            <a:custGeom>
              <a:avLst/>
              <a:gdLst/>
              <a:ahLst/>
              <a:rect l="l" t="t" r="r" b="b"/>
              <a:pathLst>
                <a:path w="2845" h="224">
                  <a:moveTo>
                    <a:pt x="2845" y="224"/>
                  </a:moveTo>
                  <a:lnTo>
                    <a:pt x="0" y="224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840" bIns="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441720" y="6094440"/>
              <a:ext cx="528480" cy="1223640"/>
            </a:xfrm>
            <a:custGeom>
              <a:avLst/>
              <a:gdLst/>
              <a:ahLst/>
              <a:rect l="l" t="t" r="r" b="b"/>
              <a:pathLst>
                <a:path w="2560" h="3407">
                  <a:moveTo>
                    <a:pt x="2560" y="3407"/>
                  </a:moveTo>
                  <a:lnTo>
                    <a:pt x="0" y="3407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4671000" y="7225200"/>
              <a:ext cx="71640" cy="104400"/>
            </a:xfrm>
            <a:custGeom>
              <a:avLst/>
              <a:gdLst/>
              <a:ahLst/>
              <a:rect l="l" t="t" r="r" b="b"/>
              <a:pathLst>
                <a:path w="351" h="294">
                  <a:moveTo>
                    <a:pt x="351" y="0"/>
                  </a:moveTo>
                  <a:lnTo>
                    <a:pt x="0" y="0"/>
                  </a:lnTo>
                  <a:lnTo>
                    <a:pt x="0" y="294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2661120" y="4646880"/>
              <a:ext cx="729000" cy="36000"/>
            </a:xfrm>
            <a:custGeom>
              <a:avLst/>
              <a:gdLst/>
              <a:ahLst/>
              <a:rect l="l" t="t" r="r" b="b"/>
              <a:pathLst>
                <a:path w="3529" h="99">
                  <a:moveTo>
                    <a:pt x="3529" y="0"/>
                  </a:moveTo>
                  <a:lnTo>
                    <a:pt x="0" y="0"/>
                  </a:lnTo>
                  <a:lnTo>
                    <a:pt x="0" y="99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975960" y="3520440"/>
              <a:ext cx="1114560" cy="53640"/>
            </a:xfrm>
            <a:custGeom>
              <a:avLst/>
              <a:gdLst/>
              <a:ahLst/>
              <a:rect l="l" t="t" r="r" b="b"/>
              <a:pathLst>
                <a:path w="5399" h="149">
                  <a:moveTo>
                    <a:pt x="5399" y="149"/>
                  </a:moveTo>
                  <a:lnTo>
                    <a:pt x="0" y="149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3044880" y="4486680"/>
              <a:ext cx="1017000" cy="53640"/>
            </a:xfrm>
            <a:custGeom>
              <a:avLst/>
              <a:gdLst/>
              <a:ahLst/>
              <a:rect l="l" t="t" r="r" b="b"/>
              <a:pathLst>
                <a:path w="4927" h="149">
                  <a:moveTo>
                    <a:pt x="4927" y="149"/>
                  </a:moveTo>
                  <a:lnTo>
                    <a:pt x="0" y="149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970200" y="7318080"/>
              <a:ext cx="1677600" cy="862200"/>
            </a:xfrm>
            <a:custGeom>
              <a:avLst/>
              <a:gdLst/>
              <a:ahLst/>
              <a:rect l="l" t="t" r="r" b="b"/>
              <a:pathLst>
                <a:path w="8121" h="2398">
                  <a:moveTo>
                    <a:pt x="8121" y="2398"/>
                  </a:moveTo>
                  <a:lnTo>
                    <a:pt x="0" y="2398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3636720" y="7436880"/>
              <a:ext cx="667440" cy="214200"/>
            </a:xfrm>
            <a:custGeom>
              <a:avLst/>
              <a:gdLst/>
              <a:ahLst/>
              <a:rect l="l" t="t" r="r" b="b"/>
              <a:pathLst>
                <a:path w="3232" h="596">
                  <a:moveTo>
                    <a:pt x="3232" y="0"/>
                  </a:moveTo>
                  <a:lnTo>
                    <a:pt x="0" y="0"/>
                  </a:lnTo>
                  <a:lnTo>
                    <a:pt x="0" y="596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4743000" y="7120080"/>
              <a:ext cx="303480" cy="104760"/>
            </a:xfrm>
            <a:custGeom>
              <a:avLst/>
              <a:gdLst/>
              <a:ahLst/>
              <a:rect l="l" t="t" r="r" b="b"/>
              <a:pathLst>
                <a:path w="1466" h="290">
                  <a:moveTo>
                    <a:pt x="1466" y="0"/>
                  </a:moveTo>
                  <a:lnTo>
                    <a:pt x="0" y="0"/>
                  </a:lnTo>
                  <a:lnTo>
                    <a:pt x="0" y="29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4960440" y="7865640"/>
              <a:ext cx="25920" cy="214200"/>
            </a:xfrm>
            <a:custGeom>
              <a:avLst/>
              <a:gdLst/>
              <a:ahLst/>
              <a:rect l="l" t="t" r="r" b="b"/>
              <a:pathLst>
                <a:path w="122" h="597">
                  <a:moveTo>
                    <a:pt x="122" y="0"/>
                  </a:moveTo>
                  <a:lnTo>
                    <a:pt x="0" y="0"/>
                  </a:lnTo>
                  <a:lnTo>
                    <a:pt x="0" y="597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2864520" y="1536480"/>
              <a:ext cx="825120" cy="18000"/>
            </a:xfrm>
            <a:custGeom>
              <a:avLst/>
              <a:gdLst/>
              <a:ahLst/>
              <a:rect l="l" t="t" r="r" b="b"/>
              <a:pathLst>
                <a:path w="3993" h="50">
                  <a:moveTo>
                    <a:pt x="3993" y="0"/>
                  </a:moveTo>
                  <a:lnTo>
                    <a:pt x="0" y="0"/>
                  </a:lnTo>
                  <a:lnTo>
                    <a:pt x="0" y="5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800" bIns="-28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4105440" y="7865640"/>
              <a:ext cx="855000" cy="214200"/>
            </a:xfrm>
            <a:custGeom>
              <a:avLst/>
              <a:gdLst/>
              <a:ahLst/>
              <a:rect l="l" t="t" r="r" b="b"/>
              <a:pathLst>
                <a:path w="4141" h="597">
                  <a:moveTo>
                    <a:pt x="4141" y="597"/>
                  </a:moveTo>
                  <a:lnTo>
                    <a:pt x="0" y="597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1464840" y="5407200"/>
              <a:ext cx="837720" cy="424440"/>
            </a:xfrm>
            <a:custGeom>
              <a:avLst/>
              <a:gdLst/>
              <a:ahLst/>
              <a:rect l="l" t="t" r="r" b="b"/>
              <a:pathLst>
                <a:path w="4053" h="1181">
                  <a:moveTo>
                    <a:pt x="4053" y="0"/>
                  </a:moveTo>
                  <a:lnTo>
                    <a:pt x="0" y="0"/>
                  </a:lnTo>
                  <a:lnTo>
                    <a:pt x="0" y="1181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5046840" y="7019640"/>
              <a:ext cx="55800" cy="100080"/>
            </a:xfrm>
            <a:custGeom>
              <a:avLst/>
              <a:gdLst/>
              <a:ahLst/>
              <a:rect l="l" t="t" r="r" b="b"/>
              <a:pathLst>
                <a:path w="270" h="279">
                  <a:moveTo>
                    <a:pt x="270" y="0"/>
                  </a:moveTo>
                  <a:lnTo>
                    <a:pt x="0" y="0"/>
                  </a:lnTo>
                  <a:lnTo>
                    <a:pt x="0" y="279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2920320" y="4191120"/>
              <a:ext cx="564120" cy="80640"/>
            </a:xfrm>
            <a:custGeom>
              <a:avLst/>
              <a:gdLst/>
              <a:ahLst/>
              <a:rect l="l" t="t" r="r" b="b"/>
              <a:pathLst>
                <a:path w="2735" h="224">
                  <a:moveTo>
                    <a:pt x="2735" y="224"/>
                  </a:moveTo>
                  <a:lnTo>
                    <a:pt x="0" y="224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840" bIns="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763920" y="2867760"/>
              <a:ext cx="415440" cy="246240"/>
            </a:xfrm>
            <a:custGeom>
              <a:avLst/>
              <a:gdLst/>
              <a:ahLst/>
              <a:rect l="l" t="t" r="r" b="b"/>
              <a:pathLst>
                <a:path w="2011" h="685">
                  <a:moveTo>
                    <a:pt x="2011" y="0"/>
                  </a:moveTo>
                  <a:lnTo>
                    <a:pt x="0" y="0"/>
                  </a:lnTo>
                  <a:lnTo>
                    <a:pt x="0" y="685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5151240" y="6926400"/>
              <a:ext cx="28440" cy="79560"/>
            </a:xfrm>
            <a:custGeom>
              <a:avLst/>
              <a:gdLst/>
              <a:ahLst/>
              <a:rect l="l" t="t" r="r" b="b"/>
              <a:pathLst>
                <a:path w="139" h="224">
                  <a:moveTo>
                    <a:pt x="139" y="224"/>
                  </a:moveTo>
                  <a:lnTo>
                    <a:pt x="0" y="224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5102640" y="6926400"/>
              <a:ext cx="48600" cy="92880"/>
            </a:xfrm>
            <a:custGeom>
              <a:avLst/>
              <a:gdLst/>
              <a:ahLst/>
              <a:rect l="l" t="t" r="r" b="b"/>
              <a:pathLst>
                <a:path w="238" h="262">
                  <a:moveTo>
                    <a:pt x="238" y="0"/>
                  </a:moveTo>
                  <a:lnTo>
                    <a:pt x="0" y="0"/>
                  </a:lnTo>
                  <a:lnTo>
                    <a:pt x="0" y="262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080" bIns="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3472200" y="8561520"/>
              <a:ext cx="641520" cy="147960"/>
            </a:xfrm>
            <a:custGeom>
              <a:avLst/>
              <a:gdLst/>
              <a:ahLst/>
              <a:rect l="l" t="t" r="r" b="b"/>
              <a:pathLst>
                <a:path w="3108" h="411">
                  <a:moveTo>
                    <a:pt x="3108" y="0"/>
                  </a:moveTo>
                  <a:lnTo>
                    <a:pt x="0" y="0"/>
                  </a:lnTo>
                  <a:lnTo>
                    <a:pt x="0" y="411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2449080" y="1980360"/>
              <a:ext cx="290520" cy="467640"/>
            </a:xfrm>
            <a:custGeom>
              <a:avLst/>
              <a:gdLst/>
              <a:ahLst/>
              <a:rect l="l" t="t" r="r" b="b"/>
              <a:pathLst>
                <a:path w="1414" h="1304">
                  <a:moveTo>
                    <a:pt x="1414" y="1304"/>
                  </a:moveTo>
                  <a:lnTo>
                    <a:pt x="0" y="1304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3636720" y="7651080"/>
              <a:ext cx="468360" cy="214560"/>
            </a:xfrm>
            <a:custGeom>
              <a:avLst/>
              <a:gdLst/>
              <a:ahLst/>
              <a:rect l="l" t="t" r="r" b="b"/>
              <a:pathLst>
                <a:path w="2267" h="596">
                  <a:moveTo>
                    <a:pt x="2267" y="596"/>
                  </a:moveTo>
                  <a:lnTo>
                    <a:pt x="0" y="596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2860200" y="5344200"/>
              <a:ext cx="968400" cy="79560"/>
            </a:xfrm>
            <a:custGeom>
              <a:avLst/>
              <a:gdLst/>
              <a:ahLst/>
              <a:rect l="l" t="t" r="r" b="b"/>
              <a:pathLst>
                <a:path w="4688" h="224">
                  <a:moveTo>
                    <a:pt x="4688" y="0"/>
                  </a:moveTo>
                  <a:lnTo>
                    <a:pt x="0" y="0"/>
                  </a:lnTo>
                  <a:lnTo>
                    <a:pt x="0" y="224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1464840" y="5831640"/>
              <a:ext cx="936720" cy="424440"/>
            </a:xfrm>
            <a:custGeom>
              <a:avLst/>
              <a:gdLst/>
              <a:ahLst/>
              <a:rect l="l" t="t" r="r" b="b"/>
              <a:pathLst>
                <a:path w="4535" h="1180">
                  <a:moveTo>
                    <a:pt x="4535" y="1180"/>
                  </a:moveTo>
                  <a:lnTo>
                    <a:pt x="0" y="1180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2381760" y="3735000"/>
              <a:ext cx="932400" cy="54000"/>
            </a:xfrm>
            <a:custGeom>
              <a:avLst/>
              <a:gdLst/>
              <a:ahLst/>
              <a:rect l="l" t="t" r="r" b="b"/>
              <a:pathLst>
                <a:path w="4515" h="149">
                  <a:moveTo>
                    <a:pt x="4515" y="149"/>
                  </a:moveTo>
                  <a:lnTo>
                    <a:pt x="0" y="149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1179360" y="2482560"/>
              <a:ext cx="488520" cy="385200"/>
            </a:xfrm>
            <a:custGeom>
              <a:avLst/>
              <a:gdLst/>
              <a:ahLst/>
              <a:rect l="l" t="t" r="r" b="b"/>
              <a:pathLst>
                <a:path w="2367" h="1073">
                  <a:moveTo>
                    <a:pt x="2367" y="0"/>
                  </a:moveTo>
                  <a:lnTo>
                    <a:pt x="0" y="0"/>
                  </a:lnTo>
                  <a:lnTo>
                    <a:pt x="0" y="1073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2064960" y="2877120"/>
              <a:ext cx="835200" cy="107640"/>
            </a:xfrm>
            <a:custGeom>
              <a:avLst/>
              <a:gdLst/>
              <a:ahLst/>
              <a:rect l="l" t="t" r="r" b="b"/>
              <a:pathLst>
                <a:path w="4045" h="299">
                  <a:moveTo>
                    <a:pt x="4045" y="0"/>
                  </a:moveTo>
                  <a:lnTo>
                    <a:pt x="0" y="0"/>
                  </a:lnTo>
                  <a:lnTo>
                    <a:pt x="0" y="299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3914640" y="8775720"/>
              <a:ext cx="773280" cy="81000"/>
            </a:xfrm>
            <a:custGeom>
              <a:avLst/>
              <a:gdLst/>
              <a:ahLst/>
              <a:rect l="l" t="t" r="r" b="b"/>
              <a:pathLst>
                <a:path w="3741" h="224">
                  <a:moveTo>
                    <a:pt x="3741" y="0"/>
                  </a:moveTo>
                  <a:lnTo>
                    <a:pt x="0" y="0"/>
                  </a:lnTo>
                  <a:lnTo>
                    <a:pt x="0" y="224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2848680" y="2662560"/>
              <a:ext cx="25920" cy="54000"/>
            </a:xfrm>
            <a:custGeom>
              <a:avLst/>
              <a:gdLst/>
              <a:ahLst/>
              <a:rect l="l" t="t" r="r" b="b"/>
              <a:pathLst>
                <a:path w="122" h="149">
                  <a:moveTo>
                    <a:pt x="122" y="149"/>
                  </a:moveTo>
                  <a:lnTo>
                    <a:pt x="0" y="149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975960" y="3466440"/>
              <a:ext cx="1136160" cy="54000"/>
            </a:xfrm>
            <a:custGeom>
              <a:avLst/>
              <a:gdLst/>
              <a:ahLst/>
              <a:rect l="l" t="t" r="r" b="b"/>
              <a:pathLst>
                <a:path w="5505" h="150">
                  <a:moveTo>
                    <a:pt x="5505" y="0"/>
                  </a:moveTo>
                  <a:lnTo>
                    <a:pt x="0" y="0"/>
                  </a:lnTo>
                  <a:lnTo>
                    <a:pt x="0" y="15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2848680" y="2608920"/>
              <a:ext cx="50040" cy="53640"/>
            </a:xfrm>
            <a:custGeom>
              <a:avLst/>
              <a:gdLst/>
              <a:ahLst/>
              <a:rect l="l" t="t" r="r" b="b"/>
              <a:pathLst>
                <a:path w="239" h="149">
                  <a:moveTo>
                    <a:pt x="239" y="0"/>
                  </a:moveTo>
                  <a:lnTo>
                    <a:pt x="0" y="0"/>
                  </a:lnTo>
                  <a:lnTo>
                    <a:pt x="0" y="149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1668240" y="1980360"/>
              <a:ext cx="780480" cy="502200"/>
            </a:xfrm>
            <a:custGeom>
              <a:avLst/>
              <a:gdLst/>
              <a:ahLst/>
              <a:rect l="l" t="t" r="r" b="b"/>
              <a:pathLst>
                <a:path w="3779" h="1398">
                  <a:moveTo>
                    <a:pt x="3779" y="0"/>
                  </a:moveTo>
                  <a:lnTo>
                    <a:pt x="0" y="0"/>
                  </a:lnTo>
                  <a:lnTo>
                    <a:pt x="0" y="1398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3712680" y="6094440"/>
              <a:ext cx="55800" cy="54000"/>
            </a:xfrm>
            <a:custGeom>
              <a:avLst/>
              <a:gdLst/>
              <a:ahLst/>
              <a:rect l="l" t="t" r="r" b="b"/>
              <a:pathLst>
                <a:path w="271" h="150">
                  <a:moveTo>
                    <a:pt x="271" y="150"/>
                  </a:moveTo>
                  <a:lnTo>
                    <a:pt x="0" y="150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3044880" y="4432320"/>
              <a:ext cx="1143360" cy="54000"/>
            </a:xfrm>
            <a:custGeom>
              <a:avLst/>
              <a:gdLst/>
              <a:ahLst/>
              <a:rect l="l" t="t" r="r" b="b"/>
              <a:pathLst>
                <a:path w="5531" h="149">
                  <a:moveTo>
                    <a:pt x="5531" y="0"/>
                  </a:moveTo>
                  <a:lnTo>
                    <a:pt x="0" y="0"/>
                  </a:lnTo>
                  <a:lnTo>
                    <a:pt x="0" y="149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4960440" y="8079840"/>
              <a:ext cx="24120" cy="106200"/>
            </a:xfrm>
            <a:custGeom>
              <a:avLst/>
              <a:gdLst/>
              <a:ahLst/>
              <a:rect l="l" t="t" r="r" b="b"/>
              <a:pathLst>
                <a:path w="120" h="298">
                  <a:moveTo>
                    <a:pt x="120" y="298"/>
                  </a:moveTo>
                  <a:lnTo>
                    <a:pt x="0" y="298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763920" y="3114000"/>
              <a:ext cx="1257840" cy="245880"/>
            </a:xfrm>
            <a:custGeom>
              <a:avLst/>
              <a:gdLst/>
              <a:ahLst/>
              <a:rect l="l" t="t" r="r" b="b"/>
              <a:pathLst>
                <a:path w="6096" h="686">
                  <a:moveTo>
                    <a:pt x="6096" y="686"/>
                  </a:moveTo>
                  <a:lnTo>
                    <a:pt x="0" y="686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4105440" y="7651080"/>
              <a:ext cx="585720" cy="214560"/>
            </a:xfrm>
            <a:custGeom>
              <a:avLst/>
              <a:gdLst/>
              <a:ahLst/>
              <a:rect l="l" t="t" r="r" b="b"/>
              <a:pathLst>
                <a:path w="2838" h="597">
                  <a:moveTo>
                    <a:pt x="2838" y="0"/>
                  </a:moveTo>
                  <a:lnTo>
                    <a:pt x="0" y="0"/>
                  </a:lnTo>
                  <a:lnTo>
                    <a:pt x="0" y="597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5102640" y="7019640"/>
              <a:ext cx="29880" cy="93960"/>
            </a:xfrm>
            <a:custGeom>
              <a:avLst/>
              <a:gdLst/>
              <a:ahLst/>
              <a:rect l="l" t="t" r="r" b="b"/>
              <a:pathLst>
                <a:path w="151" h="261">
                  <a:moveTo>
                    <a:pt x="151" y="261"/>
                  </a:moveTo>
                  <a:lnTo>
                    <a:pt x="0" y="261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2864520" y="1429920"/>
              <a:ext cx="233280" cy="124200"/>
            </a:xfrm>
            <a:custGeom>
              <a:avLst/>
              <a:gdLst/>
              <a:ahLst/>
              <a:rect l="l" t="t" r="r" b="b"/>
              <a:pathLst>
                <a:path w="1126" h="348">
                  <a:moveTo>
                    <a:pt x="1126" y="0"/>
                  </a:moveTo>
                  <a:lnTo>
                    <a:pt x="0" y="0"/>
                  </a:lnTo>
                  <a:lnTo>
                    <a:pt x="0" y="348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2302920" y="5407200"/>
              <a:ext cx="1167480" cy="526320"/>
            </a:xfrm>
            <a:custGeom>
              <a:avLst/>
              <a:gdLst/>
              <a:ahLst/>
              <a:rect l="l" t="t" r="r" b="b"/>
              <a:pathLst>
                <a:path w="5656" h="1466">
                  <a:moveTo>
                    <a:pt x="5656" y="1466"/>
                  </a:moveTo>
                  <a:lnTo>
                    <a:pt x="0" y="1466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3472200" y="8709840"/>
              <a:ext cx="442440" cy="147240"/>
            </a:xfrm>
            <a:custGeom>
              <a:avLst/>
              <a:gdLst/>
              <a:ahLst/>
              <a:rect l="l" t="t" r="r" b="b"/>
              <a:pathLst>
                <a:path w="2146" h="411">
                  <a:moveTo>
                    <a:pt x="2146" y="411"/>
                  </a:moveTo>
                  <a:lnTo>
                    <a:pt x="0" y="411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3424680" y="6577200"/>
              <a:ext cx="1055880" cy="53640"/>
            </a:xfrm>
            <a:custGeom>
              <a:avLst/>
              <a:gdLst/>
              <a:ahLst/>
              <a:rect l="l" t="t" r="r" b="b"/>
              <a:pathLst>
                <a:path w="5111" h="149">
                  <a:moveTo>
                    <a:pt x="5111" y="0"/>
                  </a:moveTo>
                  <a:lnTo>
                    <a:pt x="0" y="0"/>
                  </a:lnTo>
                  <a:lnTo>
                    <a:pt x="0" y="149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2449080" y="1980360"/>
              <a:ext cx="214560" cy="92520"/>
            </a:xfrm>
            <a:custGeom>
              <a:avLst/>
              <a:gdLst/>
              <a:ahLst/>
              <a:rect l="l" t="t" r="r" b="b"/>
              <a:pathLst>
                <a:path w="1044" h="259">
                  <a:moveTo>
                    <a:pt x="1044" y="259"/>
                  </a:moveTo>
                  <a:lnTo>
                    <a:pt x="0" y="259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4960440" y="8079840"/>
              <a:ext cx="332280" cy="320760"/>
            </a:xfrm>
            <a:custGeom>
              <a:avLst/>
              <a:gdLst/>
              <a:ahLst/>
              <a:rect l="l" t="t" r="r" b="b"/>
              <a:pathLst>
                <a:path w="1608" h="896">
                  <a:moveTo>
                    <a:pt x="1608" y="896"/>
                  </a:moveTo>
                  <a:lnTo>
                    <a:pt x="0" y="896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4743000" y="7225200"/>
              <a:ext cx="31320" cy="103320"/>
            </a:xfrm>
            <a:custGeom>
              <a:avLst/>
              <a:gdLst/>
              <a:ahLst/>
              <a:rect l="l" t="t" r="r" b="b"/>
              <a:pathLst>
                <a:path w="151" h="289">
                  <a:moveTo>
                    <a:pt x="151" y="289"/>
                  </a:moveTo>
                  <a:lnTo>
                    <a:pt x="0" y="289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2656440" y="3091680"/>
              <a:ext cx="707760" cy="53640"/>
            </a:xfrm>
            <a:custGeom>
              <a:avLst/>
              <a:gdLst/>
              <a:ahLst/>
              <a:rect l="l" t="t" r="r" b="b"/>
              <a:pathLst>
                <a:path w="3422" h="150">
                  <a:moveTo>
                    <a:pt x="3422" y="150"/>
                  </a:moveTo>
                  <a:lnTo>
                    <a:pt x="0" y="150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2864520" y="1554480"/>
              <a:ext cx="828000" cy="142200"/>
            </a:xfrm>
            <a:custGeom>
              <a:avLst/>
              <a:gdLst/>
              <a:ahLst/>
              <a:rect l="l" t="t" r="r" b="b"/>
              <a:pathLst>
                <a:path w="4006" h="398">
                  <a:moveTo>
                    <a:pt x="4006" y="398"/>
                  </a:moveTo>
                  <a:lnTo>
                    <a:pt x="0" y="398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2302920" y="4682880"/>
              <a:ext cx="358200" cy="724320"/>
            </a:xfrm>
            <a:custGeom>
              <a:avLst/>
              <a:gdLst/>
              <a:ahLst/>
              <a:rect l="l" t="t" r="r" b="b"/>
              <a:pathLst>
                <a:path w="1737" h="2018">
                  <a:moveTo>
                    <a:pt x="1737" y="0"/>
                  </a:moveTo>
                  <a:lnTo>
                    <a:pt x="0" y="0"/>
                  </a:lnTo>
                  <a:lnTo>
                    <a:pt x="0" y="2018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2837160" y="6470640"/>
              <a:ext cx="667440" cy="79200"/>
            </a:xfrm>
            <a:custGeom>
              <a:avLst/>
              <a:gdLst/>
              <a:ahLst/>
              <a:rect l="l" t="t" r="r" b="b"/>
              <a:pathLst>
                <a:path w="3234" h="224">
                  <a:moveTo>
                    <a:pt x="3234" y="0"/>
                  </a:moveTo>
                  <a:lnTo>
                    <a:pt x="0" y="0"/>
                  </a:lnTo>
                  <a:lnTo>
                    <a:pt x="0" y="224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0" bIns="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2648160" y="7651080"/>
              <a:ext cx="988560" cy="529560"/>
            </a:xfrm>
            <a:custGeom>
              <a:avLst/>
              <a:gdLst/>
              <a:ahLst/>
              <a:rect l="l" t="t" r="r" b="b"/>
              <a:pathLst>
                <a:path w="4790" h="1473">
                  <a:moveTo>
                    <a:pt x="4790" y="0"/>
                  </a:moveTo>
                  <a:lnTo>
                    <a:pt x="0" y="0"/>
                  </a:lnTo>
                  <a:lnTo>
                    <a:pt x="0" y="1473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3914640" y="8857080"/>
              <a:ext cx="1091520" cy="80640"/>
            </a:xfrm>
            <a:custGeom>
              <a:avLst/>
              <a:gdLst/>
              <a:ahLst/>
              <a:rect l="l" t="t" r="r" b="b"/>
              <a:pathLst>
                <a:path w="5283" h="224">
                  <a:moveTo>
                    <a:pt x="5283" y="224"/>
                  </a:moveTo>
                  <a:lnTo>
                    <a:pt x="0" y="224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840" bIns="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2449080" y="1965240"/>
              <a:ext cx="551520" cy="14760"/>
            </a:xfrm>
            <a:custGeom>
              <a:avLst/>
              <a:gdLst/>
              <a:ahLst/>
              <a:rect l="l" t="t" r="r" b="b"/>
              <a:pathLst>
                <a:path w="2672" h="40">
                  <a:moveTo>
                    <a:pt x="2672" y="0"/>
                  </a:moveTo>
                  <a:lnTo>
                    <a:pt x="0" y="0"/>
                  </a:lnTo>
                  <a:lnTo>
                    <a:pt x="0" y="4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040" bIns="-32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3424680" y="6630840"/>
              <a:ext cx="1116000" cy="54000"/>
            </a:xfrm>
            <a:custGeom>
              <a:avLst/>
              <a:gdLst/>
              <a:ahLst/>
              <a:rect l="l" t="t" r="r" b="b"/>
              <a:pathLst>
                <a:path w="5401" h="149">
                  <a:moveTo>
                    <a:pt x="5401" y="149"/>
                  </a:moveTo>
                  <a:lnTo>
                    <a:pt x="0" y="149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441720" y="3316680"/>
              <a:ext cx="534240" cy="203760"/>
            </a:xfrm>
            <a:custGeom>
              <a:avLst/>
              <a:gdLst/>
              <a:ahLst/>
              <a:rect l="l" t="t" r="r" b="b"/>
              <a:pathLst>
                <a:path w="2587" h="567">
                  <a:moveTo>
                    <a:pt x="2587" y="567"/>
                  </a:moveTo>
                  <a:lnTo>
                    <a:pt x="0" y="567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441720" y="4870080"/>
              <a:ext cx="630000" cy="1224000"/>
            </a:xfrm>
            <a:custGeom>
              <a:avLst/>
              <a:gdLst/>
              <a:ahLst/>
              <a:rect l="l" t="t" r="r" b="b"/>
              <a:pathLst>
                <a:path w="3052" h="3407">
                  <a:moveTo>
                    <a:pt x="3052" y="0"/>
                  </a:moveTo>
                  <a:lnTo>
                    <a:pt x="0" y="0"/>
                  </a:lnTo>
                  <a:lnTo>
                    <a:pt x="0" y="3407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2656440" y="3037680"/>
              <a:ext cx="1087200" cy="54000"/>
            </a:xfrm>
            <a:custGeom>
              <a:avLst/>
              <a:gdLst/>
              <a:ahLst/>
              <a:rect l="l" t="t" r="r" b="b"/>
              <a:pathLst>
                <a:path w="5266" h="149">
                  <a:moveTo>
                    <a:pt x="5266" y="0"/>
                  </a:moveTo>
                  <a:lnTo>
                    <a:pt x="0" y="0"/>
                  </a:lnTo>
                  <a:lnTo>
                    <a:pt x="0" y="149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5151240" y="6845760"/>
              <a:ext cx="54000" cy="80640"/>
            </a:xfrm>
            <a:custGeom>
              <a:avLst/>
              <a:gdLst/>
              <a:ahLst/>
              <a:rect l="l" t="t" r="r" b="b"/>
              <a:pathLst>
                <a:path w="261" h="224">
                  <a:moveTo>
                    <a:pt x="261" y="0"/>
                  </a:moveTo>
                  <a:lnTo>
                    <a:pt x="0" y="0"/>
                  </a:lnTo>
                  <a:lnTo>
                    <a:pt x="0" y="224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840" bIns="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3434760" y="4753440"/>
              <a:ext cx="919800" cy="161640"/>
            </a:xfrm>
            <a:custGeom>
              <a:avLst/>
              <a:gdLst/>
              <a:ahLst/>
              <a:rect l="l" t="t" r="r" b="b"/>
              <a:pathLst>
                <a:path w="4453" h="448">
                  <a:moveTo>
                    <a:pt x="4453" y="0"/>
                  </a:moveTo>
                  <a:lnTo>
                    <a:pt x="0" y="0"/>
                  </a:lnTo>
                  <a:lnTo>
                    <a:pt x="0" y="448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1577880" y="3908880"/>
              <a:ext cx="2076120" cy="94320"/>
            </a:xfrm>
            <a:custGeom>
              <a:avLst/>
              <a:gdLst/>
              <a:ahLst/>
              <a:rect l="l" t="t" r="r" b="b"/>
              <a:pathLst>
                <a:path w="10052" h="261">
                  <a:moveTo>
                    <a:pt x="10052" y="261"/>
                  </a:moveTo>
                  <a:lnTo>
                    <a:pt x="0" y="261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1072080" y="4870080"/>
              <a:ext cx="392760" cy="961200"/>
            </a:xfrm>
            <a:custGeom>
              <a:avLst/>
              <a:gdLst/>
              <a:ahLst/>
              <a:rect l="l" t="t" r="r" b="b"/>
              <a:pathLst>
                <a:path w="1905" h="2676">
                  <a:moveTo>
                    <a:pt x="1905" y="2676"/>
                  </a:moveTo>
                  <a:lnTo>
                    <a:pt x="0" y="2676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2739600" y="2448360"/>
              <a:ext cx="108720" cy="214200"/>
            </a:xfrm>
            <a:custGeom>
              <a:avLst/>
              <a:gdLst/>
              <a:ahLst/>
              <a:rect l="l" t="t" r="r" b="b"/>
              <a:pathLst>
                <a:path w="527" h="597">
                  <a:moveTo>
                    <a:pt x="527" y="597"/>
                  </a:moveTo>
                  <a:lnTo>
                    <a:pt x="0" y="597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2302920" y="5183640"/>
              <a:ext cx="1227600" cy="223200"/>
            </a:xfrm>
            <a:custGeom>
              <a:avLst/>
              <a:gdLst/>
              <a:ahLst/>
              <a:rect l="l" t="t" r="r" b="b"/>
              <a:pathLst>
                <a:path w="5948" h="624">
                  <a:moveTo>
                    <a:pt x="5948" y="0"/>
                  </a:moveTo>
                  <a:lnTo>
                    <a:pt x="0" y="0"/>
                  </a:lnTo>
                  <a:lnTo>
                    <a:pt x="0" y="624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3942000" y="4915440"/>
              <a:ext cx="633240" cy="52200"/>
            </a:xfrm>
            <a:custGeom>
              <a:avLst/>
              <a:gdLst/>
              <a:ahLst/>
              <a:rect l="l" t="t" r="r" b="b"/>
              <a:pathLst>
                <a:path w="3062" h="149">
                  <a:moveTo>
                    <a:pt x="3062" y="149"/>
                  </a:moveTo>
                  <a:lnTo>
                    <a:pt x="0" y="149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2920320" y="4111560"/>
              <a:ext cx="1131480" cy="79560"/>
            </a:xfrm>
            <a:custGeom>
              <a:avLst/>
              <a:gdLst/>
              <a:ahLst/>
              <a:rect l="l" t="t" r="r" b="b"/>
              <a:pathLst>
                <a:path w="5481" h="224">
                  <a:moveTo>
                    <a:pt x="5481" y="0"/>
                  </a:moveTo>
                  <a:lnTo>
                    <a:pt x="0" y="0"/>
                  </a:lnTo>
                  <a:lnTo>
                    <a:pt x="0" y="224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3692880" y="1644120"/>
              <a:ext cx="223200" cy="52560"/>
            </a:xfrm>
            <a:custGeom>
              <a:avLst/>
              <a:gdLst/>
              <a:ahLst/>
              <a:rect l="l" t="t" r="r" b="b"/>
              <a:pathLst>
                <a:path w="1081" h="149">
                  <a:moveTo>
                    <a:pt x="1081" y="0"/>
                  </a:moveTo>
                  <a:lnTo>
                    <a:pt x="0" y="0"/>
                  </a:lnTo>
                  <a:lnTo>
                    <a:pt x="0" y="149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60" bIns="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3083760" y="2394000"/>
              <a:ext cx="266400" cy="54000"/>
            </a:xfrm>
            <a:custGeom>
              <a:avLst/>
              <a:gdLst/>
              <a:ahLst/>
              <a:rect l="l" t="t" r="r" b="b"/>
              <a:pathLst>
                <a:path w="1284" h="149">
                  <a:moveTo>
                    <a:pt x="1284" y="0"/>
                  </a:moveTo>
                  <a:lnTo>
                    <a:pt x="0" y="0"/>
                  </a:lnTo>
                  <a:lnTo>
                    <a:pt x="0" y="149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2860200" y="5423760"/>
              <a:ext cx="493920" cy="80640"/>
            </a:xfrm>
            <a:custGeom>
              <a:avLst/>
              <a:gdLst/>
              <a:ahLst/>
              <a:rect l="l" t="t" r="r" b="b"/>
              <a:pathLst>
                <a:path w="2388" h="224">
                  <a:moveTo>
                    <a:pt x="2388" y="224"/>
                  </a:moveTo>
                  <a:lnTo>
                    <a:pt x="0" y="224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840" bIns="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>
              <a:off x="4304520" y="7436880"/>
              <a:ext cx="1379520" cy="106200"/>
            </a:xfrm>
            <a:custGeom>
              <a:avLst/>
              <a:gdLst/>
              <a:ahLst/>
              <a:rect l="l" t="t" r="r" b="b"/>
              <a:pathLst>
                <a:path w="6678" h="296">
                  <a:moveTo>
                    <a:pt x="6678" y="296"/>
                  </a:moveTo>
                  <a:lnTo>
                    <a:pt x="0" y="296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441720" y="3114000"/>
              <a:ext cx="322200" cy="202320"/>
            </a:xfrm>
            <a:custGeom>
              <a:avLst/>
              <a:gdLst/>
              <a:ahLst/>
              <a:rect l="l" t="t" r="r" b="b"/>
              <a:pathLst>
                <a:path w="1559" h="567">
                  <a:moveTo>
                    <a:pt x="1559" y="0"/>
                  </a:moveTo>
                  <a:lnTo>
                    <a:pt x="0" y="0"/>
                  </a:lnTo>
                  <a:lnTo>
                    <a:pt x="0" y="567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1911600" y="3735000"/>
              <a:ext cx="470160" cy="80640"/>
            </a:xfrm>
            <a:custGeom>
              <a:avLst/>
              <a:gdLst/>
              <a:ahLst/>
              <a:rect l="l" t="t" r="r" b="b"/>
              <a:pathLst>
                <a:path w="2274" h="224">
                  <a:moveTo>
                    <a:pt x="2274" y="0"/>
                  </a:moveTo>
                  <a:lnTo>
                    <a:pt x="0" y="0"/>
                  </a:lnTo>
                  <a:lnTo>
                    <a:pt x="0" y="224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840" bIns="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4960440" y="7972200"/>
              <a:ext cx="24120" cy="107640"/>
            </a:xfrm>
            <a:custGeom>
              <a:avLst/>
              <a:gdLst/>
              <a:ahLst/>
              <a:rect l="l" t="t" r="r" b="b"/>
              <a:pathLst>
                <a:path w="121" h="299">
                  <a:moveTo>
                    <a:pt x="121" y="0"/>
                  </a:moveTo>
                  <a:lnTo>
                    <a:pt x="0" y="0"/>
                  </a:lnTo>
                  <a:lnTo>
                    <a:pt x="0" y="299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>
              <a:off x="3141000" y="2179440"/>
              <a:ext cx="133200" cy="54000"/>
            </a:xfrm>
            <a:custGeom>
              <a:avLst/>
              <a:gdLst/>
              <a:ahLst/>
              <a:rect l="l" t="t" r="r" b="b"/>
              <a:pathLst>
                <a:path w="644" h="149">
                  <a:moveTo>
                    <a:pt x="644" y="0"/>
                  </a:moveTo>
                  <a:lnTo>
                    <a:pt x="0" y="0"/>
                  </a:lnTo>
                  <a:lnTo>
                    <a:pt x="0" y="149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4671000" y="7329960"/>
              <a:ext cx="39960" cy="106560"/>
            </a:xfrm>
            <a:custGeom>
              <a:avLst/>
              <a:gdLst/>
              <a:ahLst/>
              <a:rect l="l" t="t" r="r" b="b"/>
              <a:pathLst>
                <a:path w="195" h="294">
                  <a:moveTo>
                    <a:pt x="195" y="294"/>
                  </a:moveTo>
                  <a:lnTo>
                    <a:pt x="0" y="294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>
              <a:off x="2449080" y="1554480"/>
              <a:ext cx="415440" cy="425520"/>
            </a:xfrm>
            <a:custGeom>
              <a:avLst/>
              <a:gdLst/>
              <a:ahLst/>
              <a:rect l="l" t="t" r="r" b="b"/>
              <a:pathLst>
                <a:path w="2017" h="1184">
                  <a:moveTo>
                    <a:pt x="2017" y="0"/>
                  </a:moveTo>
                  <a:lnTo>
                    <a:pt x="0" y="0"/>
                  </a:lnTo>
                  <a:lnTo>
                    <a:pt x="0" y="1184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3942000" y="4861440"/>
              <a:ext cx="852480" cy="54000"/>
            </a:xfrm>
            <a:custGeom>
              <a:avLst/>
              <a:gdLst/>
              <a:ahLst/>
              <a:rect l="l" t="t" r="r" b="b"/>
              <a:pathLst>
                <a:path w="4129" h="149">
                  <a:moveTo>
                    <a:pt x="4129" y="0"/>
                  </a:moveTo>
                  <a:lnTo>
                    <a:pt x="0" y="0"/>
                  </a:lnTo>
                  <a:lnTo>
                    <a:pt x="0" y="149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2302920" y="5407200"/>
              <a:ext cx="895320" cy="311760"/>
            </a:xfrm>
            <a:custGeom>
              <a:avLst/>
              <a:gdLst/>
              <a:ahLst/>
              <a:rect l="l" t="t" r="r" b="b"/>
              <a:pathLst>
                <a:path w="4338" h="868">
                  <a:moveTo>
                    <a:pt x="4338" y="868"/>
                  </a:moveTo>
                  <a:lnTo>
                    <a:pt x="0" y="868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5205600" y="6791400"/>
              <a:ext cx="25920" cy="54000"/>
            </a:xfrm>
            <a:custGeom>
              <a:avLst/>
              <a:gdLst/>
              <a:ahLst/>
              <a:rect l="l" t="t" r="r" b="b"/>
              <a:pathLst>
                <a:path w="129" h="149">
                  <a:moveTo>
                    <a:pt x="129" y="0"/>
                  </a:moveTo>
                  <a:lnTo>
                    <a:pt x="0" y="0"/>
                  </a:lnTo>
                  <a:lnTo>
                    <a:pt x="0" y="149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>
              <a:off x="2900160" y="2877120"/>
              <a:ext cx="525600" cy="54000"/>
            </a:xfrm>
            <a:custGeom>
              <a:avLst/>
              <a:gdLst/>
              <a:ahLst/>
              <a:rect l="l" t="t" r="r" b="b"/>
              <a:pathLst>
                <a:path w="2544" h="150">
                  <a:moveTo>
                    <a:pt x="2544" y="150"/>
                  </a:moveTo>
                  <a:lnTo>
                    <a:pt x="0" y="150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2064960" y="2984760"/>
              <a:ext cx="591480" cy="106560"/>
            </a:xfrm>
            <a:custGeom>
              <a:avLst/>
              <a:gdLst/>
              <a:ahLst/>
              <a:rect l="l" t="t" r="r" b="b"/>
              <a:pathLst>
                <a:path w="2865" h="298">
                  <a:moveTo>
                    <a:pt x="2865" y="298"/>
                  </a:moveTo>
                  <a:lnTo>
                    <a:pt x="0" y="298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>
              <a:off x="2661120" y="4682880"/>
              <a:ext cx="773280" cy="232560"/>
            </a:xfrm>
            <a:custGeom>
              <a:avLst/>
              <a:gdLst/>
              <a:ahLst/>
              <a:rect l="l" t="t" r="r" b="b"/>
              <a:pathLst>
                <a:path w="3745" h="647">
                  <a:moveTo>
                    <a:pt x="3745" y="647"/>
                  </a:moveTo>
                  <a:lnTo>
                    <a:pt x="0" y="647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>
              <a:off x="3484800" y="4271760"/>
              <a:ext cx="958320" cy="54000"/>
            </a:xfrm>
            <a:custGeom>
              <a:avLst/>
              <a:gdLst/>
              <a:ahLst/>
              <a:rect l="l" t="t" r="r" b="b"/>
              <a:pathLst>
                <a:path w="4639" h="149">
                  <a:moveTo>
                    <a:pt x="4639" y="149"/>
                  </a:moveTo>
                  <a:lnTo>
                    <a:pt x="0" y="149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>
              <a:off x="1911600" y="3816000"/>
              <a:ext cx="851040" cy="81000"/>
            </a:xfrm>
            <a:custGeom>
              <a:avLst/>
              <a:gdLst/>
              <a:ahLst/>
              <a:rect l="l" t="t" r="r" b="b"/>
              <a:pathLst>
                <a:path w="4117" h="224">
                  <a:moveTo>
                    <a:pt x="4117" y="224"/>
                  </a:moveTo>
                  <a:lnTo>
                    <a:pt x="0" y="224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>
              <a:off x="3828960" y="5290200"/>
              <a:ext cx="1316520" cy="54000"/>
            </a:xfrm>
            <a:custGeom>
              <a:avLst/>
              <a:gdLst/>
              <a:ahLst/>
              <a:rect l="l" t="t" r="r" b="b"/>
              <a:pathLst>
                <a:path w="6372" h="149">
                  <a:moveTo>
                    <a:pt x="6372" y="0"/>
                  </a:moveTo>
                  <a:lnTo>
                    <a:pt x="0" y="0"/>
                  </a:lnTo>
                  <a:lnTo>
                    <a:pt x="0" y="149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"/>
            <p:cNvSpPr/>
            <p:nvPr/>
          </p:nvSpPr>
          <p:spPr>
            <a:xfrm>
              <a:off x="2302920" y="5407200"/>
              <a:ext cx="557280" cy="16560"/>
            </a:xfrm>
            <a:custGeom>
              <a:avLst/>
              <a:gdLst/>
              <a:ahLst/>
              <a:rect l="l" t="t" r="r" b="b"/>
              <a:pathLst>
                <a:path w="2703" h="47">
                  <a:moveTo>
                    <a:pt x="2703" y="47"/>
                  </a:moveTo>
                  <a:lnTo>
                    <a:pt x="0" y="47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240" bIns="-30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>
              <a:off x="2302920" y="4191120"/>
              <a:ext cx="617400" cy="1216080"/>
            </a:xfrm>
            <a:custGeom>
              <a:avLst/>
              <a:gdLst/>
              <a:ahLst/>
              <a:rect l="l" t="t" r="r" b="b"/>
              <a:pathLst>
                <a:path w="2991" h="3386">
                  <a:moveTo>
                    <a:pt x="2991" y="0"/>
                  </a:moveTo>
                  <a:lnTo>
                    <a:pt x="0" y="0"/>
                  </a:lnTo>
                  <a:lnTo>
                    <a:pt x="0" y="3386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"/>
            <p:cNvSpPr/>
            <p:nvPr/>
          </p:nvSpPr>
          <p:spPr>
            <a:xfrm>
              <a:off x="3828960" y="5344200"/>
              <a:ext cx="829440" cy="54000"/>
            </a:xfrm>
            <a:custGeom>
              <a:avLst/>
              <a:gdLst/>
              <a:ahLst/>
              <a:rect l="l" t="t" r="r" b="b"/>
              <a:pathLst>
                <a:path w="4016" h="150">
                  <a:moveTo>
                    <a:pt x="4016" y="150"/>
                  </a:moveTo>
                  <a:lnTo>
                    <a:pt x="0" y="150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"/>
            <p:cNvSpPr/>
            <p:nvPr/>
          </p:nvSpPr>
          <p:spPr>
            <a:xfrm>
              <a:off x="208080" y="4705200"/>
              <a:ext cx="233280" cy="1388880"/>
            </a:xfrm>
            <a:custGeom>
              <a:avLst/>
              <a:gdLst/>
              <a:ahLst/>
              <a:rect l="l" t="t" r="r" b="b"/>
              <a:pathLst>
                <a:path w="1133" h="3865">
                  <a:moveTo>
                    <a:pt x="1133" y="3865"/>
                  </a:moveTo>
                  <a:lnTo>
                    <a:pt x="0" y="3865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"/>
            <p:cNvSpPr/>
            <p:nvPr/>
          </p:nvSpPr>
          <p:spPr>
            <a:xfrm>
              <a:off x="2302920" y="5407200"/>
              <a:ext cx="1369800" cy="419760"/>
            </a:xfrm>
            <a:custGeom>
              <a:avLst/>
              <a:gdLst/>
              <a:ahLst/>
              <a:rect l="l" t="t" r="r" b="b"/>
              <a:pathLst>
                <a:path w="6634" h="1167">
                  <a:moveTo>
                    <a:pt x="6634" y="1167"/>
                  </a:moveTo>
                  <a:lnTo>
                    <a:pt x="0" y="1167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"/>
            <p:cNvSpPr/>
            <p:nvPr/>
          </p:nvSpPr>
          <p:spPr>
            <a:xfrm>
              <a:off x="1566360" y="6362640"/>
              <a:ext cx="1171800" cy="94320"/>
            </a:xfrm>
            <a:custGeom>
              <a:avLst/>
              <a:gdLst/>
              <a:ahLst/>
              <a:rect l="l" t="t" r="r" b="b"/>
              <a:pathLst>
                <a:path w="5673" h="261">
                  <a:moveTo>
                    <a:pt x="5673" y="0"/>
                  </a:moveTo>
                  <a:lnTo>
                    <a:pt x="0" y="0"/>
                  </a:lnTo>
                  <a:lnTo>
                    <a:pt x="0" y="261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>
              <a:off x="3692880" y="1697040"/>
              <a:ext cx="153000" cy="53640"/>
            </a:xfrm>
            <a:custGeom>
              <a:avLst/>
              <a:gdLst/>
              <a:ahLst/>
              <a:rect l="l" t="t" r="r" b="b"/>
              <a:pathLst>
                <a:path w="741" h="149">
                  <a:moveTo>
                    <a:pt x="741" y="149"/>
                  </a:moveTo>
                  <a:lnTo>
                    <a:pt x="0" y="149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"/>
            <p:cNvSpPr/>
            <p:nvPr/>
          </p:nvSpPr>
          <p:spPr>
            <a:xfrm>
              <a:off x="1577880" y="3816000"/>
              <a:ext cx="333360" cy="92880"/>
            </a:xfrm>
            <a:custGeom>
              <a:avLst/>
              <a:gdLst/>
              <a:ahLst/>
              <a:rect l="l" t="t" r="r" b="b"/>
              <a:pathLst>
                <a:path w="1619" h="261">
                  <a:moveTo>
                    <a:pt x="1619" y="0"/>
                  </a:moveTo>
                  <a:lnTo>
                    <a:pt x="0" y="0"/>
                  </a:lnTo>
                  <a:lnTo>
                    <a:pt x="0" y="261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080" bIns="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"/>
            <p:cNvSpPr/>
            <p:nvPr/>
          </p:nvSpPr>
          <p:spPr>
            <a:xfrm>
              <a:off x="2302920" y="5407200"/>
              <a:ext cx="1409760" cy="686880"/>
            </a:xfrm>
            <a:custGeom>
              <a:avLst/>
              <a:gdLst/>
              <a:ahLst/>
              <a:rect l="l" t="t" r="r" b="b"/>
              <a:pathLst>
                <a:path w="6825" h="1913">
                  <a:moveTo>
                    <a:pt x="6825" y="1913"/>
                  </a:moveTo>
                  <a:lnTo>
                    <a:pt x="0" y="1913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"/>
            <p:cNvSpPr/>
            <p:nvPr/>
          </p:nvSpPr>
          <p:spPr>
            <a:xfrm>
              <a:off x="1072080" y="3908880"/>
              <a:ext cx="505800" cy="960840"/>
            </a:xfrm>
            <a:custGeom>
              <a:avLst/>
              <a:gdLst/>
              <a:ahLst/>
              <a:rect l="l" t="t" r="r" b="b"/>
              <a:pathLst>
                <a:path w="2448" h="2675">
                  <a:moveTo>
                    <a:pt x="2448" y="0"/>
                  </a:moveTo>
                  <a:lnTo>
                    <a:pt x="0" y="0"/>
                  </a:lnTo>
                  <a:lnTo>
                    <a:pt x="0" y="2675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"/>
            <p:cNvSpPr/>
            <p:nvPr/>
          </p:nvSpPr>
          <p:spPr>
            <a:xfrm>
              <a:off x="2661120" y="4486680"/>
              <a:ext cx="383400" cy="196200"/>
            </a:xfrm>
            <a:custGeom>
              <a:avLst/>
              <a:gdLst/>
              <a:ahLst/>
              <a:rect l="l" t="t" r="r" b="b"/>
              <a:pathLst>
                <a:path w="1859" h="547">
                  <a:moveTo>
                    <a:pt x="1859" y="0"/>
                  </a:moveTo>
                  <a:lnTo>
                    <a:pt x="0" y="0"/>
                  </a:lnTo>
                  <a:lnTo>
                    <a:pt x="0" y="547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"/>
            <p:cNvSpPr/>
            <p:nvPr/>
          </p:nvSpPr>
          <p:spPr>
            <a:xfrm>
              <a:off x="208080" y="3316680"/>
              <a:ext cx="233280" cy="1388520"/>
            </a:xfrm>
            <a:custGeom>
              <a:avLst/>
              <a:gdLst/>
              <a:ahLst/>
              <a:rect l="l" t="t" r="r" b="b"/>
              <a:pathLst>
                <a:path w="1133" h="3866">
                  <a:moveTo>
                    <a:pt x="1133" y="0"/>
                  </a:moveTo>
                  <a:lnTo>
                    <a:pt x="0" y="0"/>
                  </a:lnTo>
                  <a:lnTo>
                    <a:pt x="0" y="3866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"/>
            <p:cNvSpPr/>
            <p:nvPr/>
          </p:nvSpPr>
          <p:spPr>
            <a:xfrm>
              <a:off x="1668240" y="2482560"/>
              <a:ext cx="396720" cy="502200"/>
            </a:xfrm>
            <a:custGeom>
              <a:avLst/>
              <a:gdLst/>
              <a:ahLst/>
              <a:rect l="l" t="t" r="r" b="b"/>
              <a:pathLst>
                <a:path w="1925" h="1399">
                  <a:moveTo>
                    <a:pt x="1925" y="1399"/>
                  </a:moveTo>
                  <a:lnTo>
                    <a:pt x="0" y="1399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"/>
            <p:cNvSpPr/>
            <p:nvPr/>
          </p:nvSpPr>
          <p:spPr>
            <a:xfrm>
              <a:off x="2302920" y="5407200"/>
              <a:ext cx="653400" cy="205200"/>
            </a:xfrm>
            <a:custGeom>
              <a:avLst/>
              <a:gdLst/>
              <a:ahLst/>
              <a:rect l="l" t="t" r="r" b="b"/>
              <a:pathLst>
                <a:path w="3166" h="570">
                  <a:moveTo>
                    <a:pt x="3166" y="570"/>
                  </a:moveTo>
                  <a:lnTo>
                    <a:pt x="0" y="570"/>
                  </a:lnTo>
                  <a:lnTo>
                    <a:pt x="0" y="0"/>
                  </a:lnTo>
                </a:path>
              </a:pathLst>
            </a:custGeom>
            <a:noFill/>
            <a:ln cap="rnd"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"/>
            <p:cNvSpPr/>
            <p:nvPr/>
          </p:nvSpPr>
          <p:spPr>
            <a:xfrm>
              <a:off x="4820040" y="7264080"/>
              <a:ext cx="137700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Culex flavivirus (CxFV-Mex07)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EU87906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"/>
            <p:cNvSpPr/>
            <p:nvPr/>
          </p:nvSpPr>
          <p:spPr>
            <a:xfrm>
              <a:off x="5314320" y="8339400"/>
              <a:ext cx="89676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Wang Thong virus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AY45704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"/>
            <p:cNvSpPr/>
            <p:nvPr/>
          </p:nvSpPr>
          <p:spPr>
            <a:xfrm>
              <a:off x="3390840" y="3091680"/>
              <a:ext cx="85248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Royal Farm virus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DQ23514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"/>
            <p:cNvSpPr/>
            <p:nvPr/>
          </p:nvSpPr>
          <p:spPr>
            <a:xfrm>
              <a:off x="3339000" y="2439000"/>
              <a:ext cx="138420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Spanish sheep encephalitis virus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DQ23515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"/>
            <p:cNvSpPr/>
            <p:nvPr/>
          </p:nvSpPr>
          <p:spPr>
            <a:xfrm>
              <a:off x="3506760" y="1800360"/>
              <a:ext cx="99540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Gadgets Gully virus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DQ235145</a:t>
              </a:r>
              <a:r>
                <a:rPr b="0" lang="en-US" sz="500" spc="-1" strike="noStrike">
                  <a:solidFill>
                    <a:srgbClr val="000000"/>
                  </a:solidFill>
                  <a:latin typeface="Times New Roman"/>
                </a:rPr>
                <a:t> 1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"/>
            <p:cNvSpPr/>
            <p:nvPr/>
          </p:nvSpPr>
          <p:spPr>
            <a:xfrm>
              <a:off x="5028480" y="8021520"/>
              <a:ext cx="147600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Culex theileri flavivirus isolate 210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FR87348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"/>
            <p:cNvSpPr/>
            <p:nvPr/>
          </p:nvSpPr>
          <p:spPr>
            <a:xfrm>
              <a:off x="3538440" y="6407640"/>
              <a:ext cx="70632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Modoc virus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NC_00363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"/>
            <p:cNvSpPr/>
            <p:nvPr/>
          </p:nvSpPr>
          <p:spPr>
            <a:xfrm>
              <a:off x="3028680" y="1903680"/>
              <a:ext cx="171972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Tick-borne encephalitis virus (Sofjin-HO)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AB06206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"/>
            <p:cNvSpPr/>
            <p:nvPr/>
          </p:nvSpPr>
          <p:spPr>
            <a:xfrm>
              <a:off x="3826800" y="5987880"/>
              <a:ext cx="74628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Nounane virus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EU15942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"/>
            <p:cNvSpPr/>
            <p:nvPr/>
          </p:nvSpPr>
          <p:spPr>
            <a:xfrm>
              <a:off x="5031360" y="8888400"/>
              <a:ext cx="123228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Aedes flavivirus (Narita-21)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AB48840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"/>
            <p:cNvSpPr/>
            <p:nvPr/>
          </p:nvSpPr>
          <p:spPr>
            <a:xfrm>
              <a:off x="4516560" y="5023080"/>
              <a:ext cx="100800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Dengue virus (type 4)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AY61899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"/>
            <p:cNvSpPr/>
            <p:nvPr/>
          </p:nvSpPr>
          <p:spPr>
            <a:xfrm>
              <a:off x="4577040" y="6622200"/>
              <a:ext cx="82224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Rio Bravo virus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NC_00367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"/>
            <p:cNvSpPr/>
            <p:nvPr/>
          </p:nvSpPr>
          <p:spPr>
            <a:xfrm>
              <a:off x="3778200" y="2976120"/>
              <a:ext cx="69120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Karshi virus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NC_00694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"/>
            <p:cNvSpPr/>
            <p:nvPr/>
          </p:nvSpPr>
          <p:spPr>
            <a:xfrm>
              <a:off x="4381200" y="4696560"/>
              <a:ext cx="95184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Dengue virus (type 1)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M8751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"/>
            <p:cNvSpPr/>
            <p:nvPr/>
          </p:nvSpPr>
          <p:spPr>
            <a:xfrm>
              <a:off x="5247360" y="6863760"/>
              <a:ext cx="7506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Times New Roman"/>
                </a:rPr>
                <a:t>gi166157427dbjAB262759.2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"/>
            <p:cNvSpPr/>
            <p:nvPr/>
          </p:nvSpPr>
          <p:spPr>
            <a:xfrm>
              <a:off x="3661560" y="3939120"/>
              <a:ext cx="904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Yokose virusNC_00503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"/>
            <p:cNvSpPr/>
            <p:nvPr/>
          </p:nvSpPr>
          <p:spPr>
            <a:xfrm>
              <a:off x="3753000" y="2766240"/>
              <a:ext cx="75060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Deer tick virus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AF31105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"/>
            <p:cNvSpPr/>
            <p:nvPr/>
          </p:nvSpPr>
          <p:spPr>
            <a:xfrm>
              <a:off x="2427840" y="3190680"/>
              <a:ext cx="68796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Kadam virus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DQ23514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"/>
            <p:cNvSpPr/>
            <p:nvPr/>
          </p:nvSpPr>
          <p:spPr>
            <a:xfrm>
              <a:off x="5098320" y="4153680"/>
              <a:ext cx="86940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ussuquara virus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NC_00902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"/>
            <p:cNvSpPr/>
            <p:nvPr/>
          </p:nvSpPr>
          <p:spPr>
            <a:xfrm>
              <a:off x="3561840" y="5121000"/>
              <a:ext cx="121824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Japanese encephalitis virus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NC_00143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"/>
            <p:cNvSpPr/>
            <p:nvPr/>
          </p:nvSpPr>
          <p:spPr>
            <a:xfrm>
              <a:off x="5099400" y="7693200"/>
              <a:ext cx="147600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Culex theileri flavivirus isolate 132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FR87347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"/>
            <p:cNvSpPr/>
            <p:nvPr/>
          </p:nvSpPr>
          <p:spPr>
            <a:xfrm>
              <a:off x="3330000" y="2220120"/>
              <a:ext cx="137808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Turkish sheep encephalitis virus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DQ23515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"/>
            <p:cNvSpPr/>
            <p:nvPr/>
          </p:nvSpPr>
          <p:spPr>
            <a:xfrm>
              <a:off x="5031360" y="8236080"/>
              <a:ext cx="16254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Culex theileri flavivirus PoMoFlavEU71642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"/>
            <p:cNvSpPr/>
            <p:nvPr/>
          </p:nvSpPr>
          <p:spPr>
            <a:xfrm>
              <a:off x="4595760" y="4911120"/>
              <a:ext cx="94572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Dengue</a:t>
              </a:r>
              <a:r>
                <a:rPr b="0" lang="en-US" sz="5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virus (type 2)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M1919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"/>
            <p:cNvSpPr/>
            <p:nvPr/>
          </p:nvSpPr>
          <p:spPr>
            <a:xfrm>
              <a:off x="4078800" y="4052880"/>
              <a:ext cx="80064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Kedougou virus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AY63254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"/>
            <p:cNvSpPr/>
            <p:nvPr/>
          </p:nvSpPr>
          <p:spPr>
            <a:xfrm>
              <a:off x="3937320" y="1590120"/>
              <a:ext cx="81288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Alkhurma virus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NC_00435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"/>
            <p:cNvSpPr/>
            <p:nvPr/>
          </p:nvSpPr>
          <p:spPr>
            <a:xfrm>
              <a:off x="4239360" y="8450280"/>
              <a:ext cx="106128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Cell fusing agent virus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NC_00156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"/>
            <p:cNvSpPr/>
            <p:nvPr/>
          </p:nvSpPr>
          <p:spPr>
            <a:xfrm>
              <a:off x="3380040" y="2337120"/>
              <a:ext cx="84960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Louping ill virus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NC_00180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"/>
            <p:cNvSpPr/>
            <p:nvPr/>
          </p:nvSpPr>
          <p:spPr>
            <a:xfrm>
              <a:off x="3966120" y="3615120"/>
              <a:ext cx="65916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Lammi virus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FJ60678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"/>
            <p:cNvSpPr/>
            <p:nvPr/>
          </p:nvSpPr>
          <p:spPr>
            <a:xfrm>
              <a:off x="3386880" y="5447880"/>
              <a:ext cx="81288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West Nile virus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NC_00156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"/>
            <p:cNvSpPr/>
            <p:nvPr/>
          </p:nvSpPr>
          <p:spPr>
            <a:xfrm>
              <a:off x="5175000" y="7159320"/>
              <a:ext cx="127152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Culex flavivirus (HOU24518)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FJ50299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"/>
            <p:cNvSpPr/>
            <p:nvPr/>
          </p:nvSpPr>
          <p:spPr>
            <a:xfrm>
              <a:off x="5713560" y="7482960"/>
              <a:ext cx="80064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Nakiwogo virus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GQ16580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"/>
            <p:cNvSpPr/>
            <p:nvPr/>
          </p:nvSpPr>
          <p:spPr>
            <a:xfrm>
              <a:off x="4194000" y="8553960"/>
              <a:ext cx="1780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Cell fusing agent virus (Rio Piedras02)GQ16581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"/>
            <p:cNvSpPr/>
            <p:nvPr/>
          </p:nvSpPr>
          <p:spPr>
            <a:xfrm>
              <a:off x="3438720" y="4590000"/>
              <a:ext cx="122148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St. Louis encephalitis virus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NC_00758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"/>
            <p:cNvSpPr/>
            <p:nvPr/>
          </p:nvSpPr>
          <p:spPr>
            <a:xfrm>
              <a:off x="2110320" y="3511440"/>
              <a:ext cx="75024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Tyuleniy virus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DQ23514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"/>
            <p:cNvSpPr/>
            <p:nvPr/>
          </p:nvSpPr>
          <p:spPr>
            <a:xfrm>
              <a:off x="4101480" y="4479120"/>
              <a:ext cx="64368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Rocio virus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AY63254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"/>
            <p:cNvSpPr/>
            <p:nvPr/>
          </p:nvSpPr>
          <p:spPr>
            <a:xfrm>
              <a:off x="5037840" y="7905960"/>
              <a:ext cx="147600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Culex theileri flavivirus isolate 153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FR87347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"/>
            <p:cNvSpPr/>
            <p:nvPr/>
          </p:nvSpPr>
          <p:spPr>
            <a:xfrm>
              <a:off x="3316680" y="2122560"/>
              <a:ext cx="127008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Greek goat encephalitis virus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DQ23515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"/>
            <p:cNvSpPr/>
            <p:nvPr/>
          </p:nvSpPr>
          <p:spPr>
            <a:xfrm>
              <a:off x="4752360" y="7369200"/>
              <a:ext cx="125028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Culex flavivirus (Uganda08)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GQ16580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"/>
            <p:cNvSpPr/>
            <p:nvPr/>
          </p:nvSpPr>
          <p:spPr>
            <a:xfrm>
              <a:off x="3722400" y="1474920"/>
              <a:ext cx="70020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Langat virus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NC_00369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"/>
            <p:cNvSpPr/>
            <p:nvPr/>
          </p:nvSpPr>
          <p:spPr>
            <a:xfrm>
              <a:off x="4818240" y="4804200"/>
              <a:ext cx="100800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Dengue virus (type 3)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DQ67553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"/>
            <p:cNvSpPr/>
            <p:nvPr/>
          </p:nvSpPr>
          <p:spPr>
            <a:xfrm>
              <a:off x="3233160" y="5662440"/>
              <a:ext cx="69552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guape virus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NC_00902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"/>
            <p:cNvSpPr/>
            <p:nvPr/>
          </p:nvSpPr>
          <p:spPr>
            <a:xfrm>
              <a:off x="5272920" y="6739200"/>
              <a:ext cx="113904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Culex flavivirus (Tokyo)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NC_00860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"/>
            <p:cNvSpPr/>
            <p:nvPr/>
          </p:nvSpPr>
          <p:spPr>
            <a:xfrm>
              <a:off x="5224320" y="6944400"/>
              <a:ext cx="125964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Culex flavivirus (NIID-21-2)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AB37721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"/>
            <p:cNvSpPr/>
            <p:nvPr/>
          </p:nvSpPr>
          <p:spPr>
            <a:xfrm>
              <a:off x="3459600" y="2867760"/>
              <a:ext cx="80532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Powassan virus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NC_00368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"/>
            <p:cNvSpPr/>
            <p:nvPr/>
          </p:nvSpPr>
          <p:spPr>
            <a:xfrm>
              <a:off x="2453040" y="6197760"/>
              <a:ext cx="65592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Sepik virus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NC_00871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"/>
            <p:cNvSpPr/>
            <p:nvPr/>
          </p:nvSpPr>
          <p:spPr>
            <a:xfrm>
              <a:off x="3355920" y="3730320"/>
              <a:ext cx="91980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Yellow fever virus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NC_00203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"/>
            <p:cNvSpPr/>
            <p:nvPr/>
          </p:nvSpPr>
          <p:spPr>
            <a:xfrm>
              <a:off x="4468680" y="4267440"/>
              <a:ext cx="69408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Bagaza virus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AY63254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"/>
            <p:cNvSpPr/>
            <p:nvPr/>
          </p:nvSpPr>
          <p:spPr>
            <a:xfrm>
              <a:off x="2893680" y="2653560"/>
              <a:ext cx="146844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Tick-borne encephalitis virus (Hypr)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U3929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"/>
            <p:cNvSpPr/>
            <p:nvPr/>
          </p:nvSpPr>
          <p:spPr>
            <a:xfrm>
              <a:off x="2813400" y="3838680"/>
              <a:ext cx="87552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Entebbe bat virus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NC_00871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"/>
            <p:cNvSpPr/>
            <p:nvPr/>
          </p:nvSpPr>
          <p:spPr>
            <a:xfrm>
              <a:off x="2140200" y="3409560"/>
              <a:ext cx="97128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Saumarez Reef virus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DQ23515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"/>
            <p:cNvSpPr/>
            <p:nvPr/>
          </p:nvSpPr>
          <p:spPr>
            <a:xfrm>
              <a:off x="5186880" y="5233320"/>
              <a:ext cx="66672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Usutu virus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NC_00655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"/>
            <p:cNvSpPr/>
            <p:nvPr/>
          </p:nvSpPr>
          <p:spPr>
            <a:xfrm>
              <a:off x="2926800" y="2547360"/>
              <a:ext cx="129312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Tick-borne encephalitis virus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NC_00167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"/>
            <p:cNvSpPr/>
            <p:nvPr/>
          </p:nvSpPr>
          <p:spPr>
            <a:xfrm>
              <a:off x="4698360" y="5339880"/>
              <a:ext cx="67716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Kunjin virus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AY27450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"/>
            <p:cNvSpPr/>
            <p:nvPr/>
          </p:nvSpPr>
          <p:spPr>
            <a:xfrm>
              <a:off x="3702600" y="5764320"/>
              <a:ext cx="80388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Kokobera virus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NC_00902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"/>
            <p:cNvSpPr/>
            <p:nvPr/>
          </p:nvSpPr>
          <p:spPr>
            <a:xfrm>
              <a:off x="3790800" y="6091200"/>
              <a:ext cx="72468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Nounane virus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FJ71116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"/>
            <p:cNvSpPr/>
            <p:nvPr/>
          </p:nvSpPr>
          <p:spPr>
            <a:xfrm>
              <a:off x="4220640" y="4375440"/>
              <a:ext cx="67140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lheus virus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NC_00902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"/>
            <p:cNvSpPr/>
            <p:nvPr/>
          </p:nvSpPr>
          <p:spPr>
            <a:xfrm>
              <a:off x="3872880" y="1693800"/>
              <a:ext cx="99576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Kyasanur forest virus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AY32349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"/>
            <p:cNvSpPr/>
            <p:nvPr/>
          </p:nvSpPr>
          <p:spPr>
            <a:xfrm>
              <a:off x="2765880" y="6301080"/>
              <a:ext cx="63180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Apoi virus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NC_00367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"/>
            <p:cNvSpPr/>
            <p:nvPr/>
          </p:nvSpPr>
          <p:spPr>
            <a:xfrm>
              <a:off x="2043720" y="3305880"/>
              <a:ext cx="71820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Meaban virus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DQ23514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"/>
            <p:cNvSpPr/>
            <p:nvPr/>
          </p:nvSpPr>
          <p:spPr>
            <a:xfrm>
              <a:off x="5037840" y="8129520"/>
              <a:ext cx="147600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Culex theileri flavivirus isolate 178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FR87347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"/>
            <p:cNvSpPr/>
            <p:nvPr/>
          </p:nvSpPr>
          <p:spPr>
            <a:xfrm>
              <a:off x="4723920" y="7592400"/>
              <a:ext cx="83592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Quang Binh virus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FJ64429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"/>
            <p:cNvSpPr/>
            <p:nvPr/>
          </p:nvSpPr>
          <p:spPr>
            <a:xfrm>
              <a:off x="5168520" y="7054200"/>
              <a:ext cx="112392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Culex flavivirus (Iowa07)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FJ66303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"/>
            <p:cNvSpPr/>
            <p:nvPr/>
          </p:nvSpPr>
          <p:spPr>
            <a:xfrm>
              <a:off x="3137760" y="1371600"/>
              <a:ext cx="129600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Omsk hemorragic fever virus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NC_00506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"/>
            <p:cNvSpPr/>
            <p:nvPr/>
          </p:nvSpPr>
          <p:spPr>
            <a:xfrm>
              <a:off x="3495960" y="5872320"/>
              <a:ext cx="58752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Zika virus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EU54598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"/>
            <p:cNvSpPr/>
            <p:nvPr/>
          </p:nvSpPr>
          <p:spPr>
            <a:xfrm>
              <a:off x="4521600" y="6511320"/>
              <a:ext cx="169992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Montana myotis leukoencephalitis virus 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NC_00411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"/>
            <p:cNvSpPr/>
            <p:nvPr/>
          </p:nvSpPr>
          <p:spPr>
            <a:xfrm>
              <a:off x="4719600" y="8717400"/>
              <a:ext cx="91980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Kamiti River virus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NC_00506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"/>
            <p:cNvSpPr/>
            <p:nvPr/>
          </p:nvSpPr>
          <p:spPr>
            <a:xfrm>
              <a:off x="2692440" y="2014560"/>
              <a:ext cx="178524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Tick-borne encephalitis virus (Vasilchenko)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AF06906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"/>
            <p:cNvSpPr/>
            <p:nvPr/>
          </p:nvSpPr>
          <p:spPr>
            <a:xfrm>
              <a:off x="3000960" y="5554080"/>
              <a:ext cx="142560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Murray Valley encephalitis virus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NC_00094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"/>
            <p:cNvSpPr/>
            <p:nvPr/>
          </p:nvSpPr>
          <p:spPr>
            <a:xfrm>
              <a:off x="1461240" y="6380640"/>
              <a:ext cx="113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Times New Roman"/>
                </a:rPr>
                <a:t>0.91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"/>
            <p:cNvSpPr/>
            <p:nvPr/>
          </p:nvSpPr>
          <p:spPr>
            <a:xfrm>
              <a:off x="2560680" y="4615560"/>
              <a:ext cx="113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Times New Roman"/>
                </a:rPr>
                <a:t>0.87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"/>
            <p:cNvSpPr/>
            <p:nvPr/>
          </p:nvSpPr>
          <p:spPr>
            <a:xfrm>
              <a:off x="2730600" y="6479640"/>
              <a:ext cx="113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Times New Roman"/>
                </a:rPr>
                <a:t>1.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"/>
            <p:cNvSpPr/>
            <p:nvPr/>
          </p:nvSpPr>
          <p:spPr>
            <a:xfrm>
              <a:off x="869760" y="3445560"/>
              <a:ext cx="113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Times New Roman"/>
                </a:rPr>
                <a:t>0.87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"/>
            <p:cNvSpPr/>
            <p:nvPr/>
          </p:nvSpPr>
          <p:spPr>
            <a:xfrm>
              <a:off x="966600" y="4794120"/>
              <a:ext cx="113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Times New Roman"/>
                </a:rPr>
                <a:t>1.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"/>
            <p:cNvSpPr/>
            <p:nvPr/>
          </p:nvSpPr>
          <p:spPr>
            <a:xfrm>
              <a:off x="5103720" y="6775200"/>
              <a:ext cx="113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Times New Roman"/>
                </a:rPr>
                <a:t>0.93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"/>
            <p:cNvSpPr/>
            <p:nvPr/>
          </p:nvSpPr>
          <p:spPr>
            <a:xfrm>
              <a:off x="2745000" y="2596680"/>
              <a:ext cx="113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Times New Roman"/>
                </a:rPr>
                <a:t>0.86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"/>
            <p:cNvSpPr/>
            <p:nvPr/>
          </p:nvSpPr>
          <p:spPr>
            <a:xfrm>
              <a:off x="3833640" y="4843440"/>
              <a:ext cx="113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Times New Roman"/>
                </a:rPr>
                <a:t>0.98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"/>
            <p:cNvSpPr/>
            <p:nvPr/>
          </p:nvSpPr>
          <p:spPr>
            <a:xfrm>
              <a:off x="3358080" y="8637840"/>
              <a:ext cx="113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Times New Roman"/>
                </a:rPr>
                <a:t>0.99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"/>
            <p:cNvSpPr/>
            <p:nvPr/>
          </p:nvSpPr>
          <p:spPr>
            <a:xfrm>
              <a:off x="659160" y="3037680"/>
              <a:ext cx="113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Times New Roman"/>
                </a:rPr>
                <a:t>0.79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"/>
            <p:cNvSpPr/>
            <p:nvPr/>
          </p:nvSpPr>
          <p:spPr>
            <a:xfrm>
              <a:off x="4560840" y="7259400"/>
              <a:ext cx="113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Times New Roman"/>
                </a:rPr>
                <a:t>0.88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"/>
            <p:cNvSpPr/>
            <p:nvPr/>
          </p:nvSpPr>
          <p:spPr>
            <a:xfrm>
              <a:off x="863640" y="7243200"/>
              <a:ext cx="113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Times New Roman"/>
                </a:rPr>
                <a:t>0.98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"/>
            <p:cNvSpPr/>
            <p:nvPr/>
          </p:nvSpPr>
          <p:spPr>
            <a:xfrm>
              <a:off x="4945680" y="7040520"/>
              <a:ext cx="113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Times New Roman"/>
                </a:rPr>
                <a:t>0.99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"/>
            <p:cNvSpPr/>
            <p:nvPr/>
          </p:nvSpPr>
          <p:spPr>
            <a:xfrm>
              <a:off x="4196160" y="7365960"/>
              <a:ext cx="113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Times New Roman"/>
                </a:rPr>
                <a:t>0.89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"/>
            <p:cNvSpPr/>
            <p:nvPr/>
          </p:nvSpPr>
          <p:spPr>
            <a:xfrm>
              <a:off x="1073520" y="2791800"/>
              <a:ext cx="113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Times New Roman"/>
                </a:rPr>
                <a:t>0.94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"/>
            <p:cNvSpPr/>
            <p:nvPr/>
          </p:nvSpPr>
          <p:spPr>
            <a:xfrm>
              <a:off x="3376440" y="4199760"/>
              <a:ext cx="113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Times New Roman"/>
                </a:rPr>
                <a:t>0.84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"/>
            <p:cNvSpPr/>
            <p:nvPr/>
          </p:nvSpPr>
          <p:spPr>
            <a:xfrm>
              <a:off x="2633760" y="2380680"/>
              <a:ext cx="113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Times New Roman"/>
                </a:rPr>
                <a:t>0.95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"/>
            <p:cNvSpPr/>
            <p:nvPr/>
          </p:nvSpPr>
          <p:spPr>
            <a:xfrm>
              <a:off x="3998880" y="8490960"/>
              <a:ext cx="113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Times New Roman"/>
                </a:rPr>
                <a:t>0.99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"/>
            <p:cNvSpPr/>
            <p:nvPr/>
          </p:nvSpPr>
          <p:spPr>
            <a:xfrm>
              <a:off x="2552760" y="3016440"/>
              <a:ext cx="113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Times New Roman"/>
                </a:rPr>
                <a:t>0.96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"/>
            <p:cNvSpPr/>
            <p:nvPr/>
          </p:nvSpPr>
          <p:spPr>
            <a:xfrm>
              <a:off x="3719520" y="5272200"/>
              <a:ext cx="113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Times New Roman"/>
                </a:rPr>
                <a:t>0.86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"/>
            <p:cNvSpPr/>
            <p:nvPr/>
          </p:nvSpPr>
          <p:spPr>
            <a:xfrm>
              <a:off x="1562760" y="2405880"/>
              <a:ext cx="113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Times New Roman"/>
                </a:rPr>
                <a:t>0.95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"/>
            <p:cNvSpPr/>
            <p:nvPr/>
          </p:nvSpPr>
          <p:spPr>
            <a:xfrm>
              <a:off x="2342160" y="1908000"/>
              <a:ext cx="113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Times New Roman"/>
                </a:rPr>
                <a:t>1.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"/>
            <p:cNvSpPr/>
            <p:nvPr/>
          </p:nvSpPr>
          <p:spPr>
            <a:xfrm>
              <a:off x="2819160" y="4126320"/>
              <a:ext cx="113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Times New Roman"/>
                </a:rPr>
                <a:t>0.91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"/>
            <p:cNvSpPr/>
            <p:nvPr/>
          </p:nvSpPr>
          <p:spPr>
            <a:xfrm>
              <a:off x="339840" y="6014520"/>
              <a:ext cx="113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Times New Roman"/>
                </a:rPr>
                <a:t>0.98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"/>
            <p:cNvSpPr/>
            <p:nvPr/>
          </p:nvSpPr>
          <p:spPr>
            <a:xfrm>
              <a:off x="335520" y="3241800"/>
              <a:ext cx="113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Times New Roman"/>
                </a:rPr>
                <a:t>0.98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"/>
            <p:cNvSpPr/>
            <p:nvPr/>
          </p:nvSpPr>
          <p:spPr>
            <a:xfrm>
              <a:off x="2527560" y="8108280"/>
              <a:ext cx="113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Times New Roman"/>
                </a:rPr>
                <a:t>1.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"/>
            <p:cNvSpPr/>
            <p:nvPr/>
          </p:nvSpPr>
          <p:spPr>
            <a:xfrm>
              <a:off x="3529080" y="7577640"/>
              <a:ext cx="113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Times New Roman"/>
                </a:rPr>
                <a:t>1.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"/>
            <p:cNvSpPr/>
            <p:nvPr/>
          </p:nvSpPr>
          <p:spPr>
            <a:xfrm>
              <a:off x="2462040" y="9003960"/>
              <a:ext cx="0" cy="71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"/>
            <p:cNvSpPr/>
            <p:nvPr/>
          </p:nvSpPr>
          <p:spPr>
            <a:xfrm>
              <a:off x="3376080" y="9002160"/>
              <a:ext cx="0" cy="72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0" bIns="25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"/>
            <p:cNvSpPr/>
            <p:nvPr/>
          </p:nvSpPr>
          <p:spPr>
            <a:xfrm>
              <a:off x="2192400" y="5339880"/>
              <a:ext cx="113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Times New Roman"/>
                </a:rPr>
                <a:t>1.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"/>
            <p:cNvSpPr/>
            <p:nvPr/>
          </p:nvSpPr>
          <p:spPr>
            <a:xfrm>
              <a:off x="3600720" y="6025320"/>
              <a:ext cx="113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Times New Roman"/>
                </a:rPr>
                <a:t>1.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"/>
            <p:cNvSpPr/>
            <p:nvPr/>
          </p:nvSpPr>
          <p:spPr>
            <a:xfrm>
              <a:off x="3332520" y="4843440"/>
              <a:ext cx="113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Times New Roman"/>
                </a:rPr>
                <a:t>1.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"/>
            <p:cNvSpPr/>
            <p:nvPr/>
          </p:nvSpPr>
          <p:spPr>
            <a:xfrm>
              <a:off x="3036960" y="2164680"/>
              <a:ext cx="113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Times New Roman"/>
                </a:rPr>
                <a:t>1.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"/>
            <p:cNvSpPr/>
            <p:nvPr/>
          </p:nvSpPr>
          <p:spPr>
            <a:xfrm>
              <a:off x="2976840" y="2380680"/>
              <a:ext cx="113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Times New Roman"/>
                </a:rPr>
                <a:t>1.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"/>
            <p:cNvSpPr/>
            <p:nvPr/>
          </p:nvSpPr>
          <p:spPr>
            <a:xfrm>
              <a:off x="2802240" y="2806560"/>
              <a:ext cx="113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Times New Roman"/>
                </a:rPr>
                <a:t>1.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"/>
            <p:cNvSpPr/>
            <p:nvPr/>
          </p:nvSpPr>
          <p:spPr>
            <a:xfrm>
              <a:off x="3584520" y="1630440"/>
              <a:ext cx="113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Times New Roman"/>
                </a:rPr>
                <a:t>1.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"/>
            <p:cNvSpPr/>
            <p:nvPr/>
          </p:nvSpPr>
          <p:spPr>
            <a:xfrm>
              <a:off x="5042880" y="7806960"/>
              <a:ext cx="147600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1222200"/>
                  <a:tab algn="l" pos="2444760"/>
                  <a:tab algn="l" pos="3666960"/>
                  <a:tab algn="l" pos="4889520"/>
                  <a:tab algn="l" pos="6111720"/>
                  <a:tab algn="l" pos="7334280"/>
                  <a:tab algn="l" pos="8556480"/>
                  <a:tab algn="l" pos="977904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Culex theileri flavivirus isolate 153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FR87347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"/>
            <p:cNvSpPr/>
            <p:nvPr/>
          </p:nvSpPr>
          <p:spPr>
            <a:xfrm>
              <a:off x="4851720" y="8010720"/>
              <a:ext cx="113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Times New Roman"/>
                </a:rPr>
                <a:t>1.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3-14T12:29:40Z</dcterms:created>
  <dc:creator>ricardo</dc:creator>
  <dc:description/>
  <dc:language>en-US</dc:language>
  <cp:lastModifiedBy>ricardo</cp:lastModifiedBy>
  <dcterms:modified xsi:type="dcterms:W3CDTF">2012-03-22T11:06:12Z</dcterms:modified>
  <cp:revision>2</cp:revision>
  <dc:subject/>
  <dc:title>Slide 1</dc:title>
</cp:coreProperties>
</file>